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03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338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984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E6CD37-389B-4E0C-8D51-C10D7B7FA135}" type="datetimeFigureOut">
              <a:rPr kumimoji="1" lang="ja-JP" altLang="en-US" smtClean="0"/>
              <a:t>2023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D4215-6A44-4F61-91DD-7439C1C0A4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11731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E6CD37-389B-4E0C-8D51-C10D7B7FA135}" type="datetimeFigureOut">
              <a:rPr kumimoji="1" lang="ja-JP" altLang="en-US" smtClean="0"/>
              <a:t>2023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D4215-6A44-4F61-91DD-7439C1C0A4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43932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E6CD37-389B-4E0C-8D51-C10D7B7FA135}" type="datetimeFigureOut">
              <a:rPr kumimoji="1" lang="ja-JP" altLang="en-US" smtClean="0"/>
              <a:t>2023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D4215-6A44-4F61-91DD-7439C1C0A4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67821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E6CD37-389B-4E0C-8D51-C10D7B7FA135}" type="datetimeFigureOut">
              <a:rPr kumimoji="1" lang="ja-JP" altLang="en-US" smtClean="0"/>
              <a:t>2023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D4215-6A44-4F61-91DD-7439C1C0A4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94547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E6CD37-389B-4E0C-8D51-C10D7B7FA135}" type="datetimeFigureOut">
              <a:rPr kumimoji="1" lang="ja-JP" altLang="en-US" smtClean="0"/>
              <a:t>2023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D4215-6A44-4F61-91DD-7439C1C0A4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45474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E6CD37-389B-4E0C-8D51-C10D7B7FA135}" type="datetimeFigureOut">
              <a:rPr kumimoji="1" lang="ja-JP" altLang="en-US" smtClean="0"/>
              <a:t>2023/8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D4215-6A44-4F61-91DD-7439C1C0A4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90031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E6CD37-389B-4E0C-8D51-C10D7B7FA135}" type="datetimeFigureOut">
              <a:rPr kumimoji="1" lang="ja-JP" altLang="en-US" smtClean="0"/>
              <a:t>2023/8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D4215-6A44-4F61-91DD-7439C1C0A4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53405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E6CD37-389B-4E0C-8D51-C10D7B7FA135}" type="datetimeFigureOut">
              <a:rPr kumimoji="1" lang="ja-JP" altLang="en-US" smtClean="0"/>
              <a:t>2023/8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D4215-6A44-4F61-91DD-7439C1C0A4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48008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E6CD37-389B-4E0C-8D51-C10D7B7FA135}" type="datetimeFigureOut">
              <a:rPr kumimoji="1" lang="ja-JP" altLang="en-US" smtClean="0"/>
              <a:t>2023/8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D4215-6A44-4F61-91DD-7439C1C0A4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8475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E6CD37-389B-4E0C-8D51-C10D7B7FA135}" type="datetimeFigureOut">
              <a:rPr kumimoji="1" lang="ja-JP" altLang="en-US" smtClean="0"/>
              <a:t>2023/8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D4215-6A44-4F61-91DD-7439C1C0A4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76559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E6CD37-389B-4E0C-8D51-C10D7B7FA135}" type="datetimeFigureOut">
              <a:rPr kumimoji="1" lang="ja-JP" altLang="en-US" smtClean="0"/>
              <a:t>2023/8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D4215-6A44-4F61-91DD-7439C1C0A4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24860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E6CD37-389B-4E0C-8D51-C10D7B7FA135}" type="datetimeFigureOut">
              <a:rPr kumimoji="1" lang="ja-JP" altLang="en-US" smtClean="0"/>
              <a:t>2023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1D4215-6A44-4F61-91DD-7439C1C0A4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16171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7313BC9D-FA1F-5C19-1F3E-2E269237B3F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58380509"/>
              </p:ext>
            </p:extLst>
          </p:nvPr>
        </p:nvGraphicFramePr>
        <p:xfrm>
          <a:off x="1212103" y="345747"/>
          <a:ext cx="6677247" cy="2118781"/>
        </p:xfrm>
        <a:graphic>
          <a:graphicData uri="http://schemas.openxmlformats.org/drawingml/2006/table">
            <a:tbl>
              <a:tblPr/>
              <a:tblGrid>
                <a:gridCol w="1992638">
                  <a:extLst>
                    <a:ext uri="{9D8B030D-6E8A-4147-A177-3AD203B41FA5}">
                      <a16:colId xmlns:a16="http://schemas.microsoft.com/office/drawing/2014/main" val="1336963559"/>
                    </a:ext>
                  </a:extLst>
                </a:gridCol>
                <a:gridCol w="1148188">
                  <a:extLst>
                    <a:ext uri="{9D8B030D-6E8A-4147-A177-3AD203B41FA5}">
                      <a16:colId xmlns:a16="http://schemas.microsoft.com/office/drawing/2014/main" val="272738333"/>
                    </a:ext>
                  </a:extLst>
                </a:gridCol>
                <a:gridCol w="1163498">
                  <a:extLst>
                    <a:ext uri="{9D8B030D-6E8A-4147-A177-3AD203B41FA5}">
                      <a16:colId xmlns:a16="http://schemas.microsoft.com/office/drawing/2014/main" val="2798991161"/>
                    </a:ext>
                  </a:extLst>
                </a:gridCol>
                <a:gridCol w="2372923">
                  <a:extLst>
                    <a:ext uri="{9D8B030D-6E8A-4147-A177-3AD203B41FA5}">
                      <a16:colId xmlns:a16="http://schemas.microsoft.com/office/drawing/2014/main" val="1019444976"/>
                    </a:ext>
                  </a:extLst>
                </a:gridCol>
              </a:tblGrid>
              <a:tr h="42519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Group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Gender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ge</a:t>
                      </a:r>
                      <a:b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（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verage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）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moking history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45383168"/>
                  </a:ext>
                </a:extLst>
              </a:tr>
              <a:tr h="84126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ontrol </a:t>
                      </a:r>
                      <a:b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=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M: 3</a:t>
                      </a:r>
                      <a:b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F: 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urrent/Past smoker: 1</a:t>
                      </a:r>
                      <a:b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on-smoker: 3</a:t>
                      </a:r>
                      <a:b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o answer: 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98928521"/>
                  </a:ext>
                </a:extLst>
              </a:tr>
              <a:tr h="84126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-PT84</a:t>
                      </a:r>
                      <a:b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=1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M: 11</a:t>
                      </a:r>
                      <a:b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F: 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4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urrent/Past smoker: 4</a:t>
                      </a:r>
                      <a:b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on-smoker: 8</a:t>
                      </a:r>
                    </a:p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o answer: 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81915534"/>
                  </a:ext>
                </a:extLst>
              </a:tr>
            </a:tbl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E570AA6-9CFE-95E0-B716-AE3314FCEDCB}"/>
              </a:ext>
            </a:extLst>
          </p:cNvPr>
          <p:cNvSpPr txBox="1"/>
          <p:nvPr/>
        </p:nvSpPr>
        <p:spPr>
          <a:xfrm>
            <a:off x="227652" y="6251349"/>
            <a:ext cx="30489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dditional file 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FA3ECB56-7734-B19B-0599-BB46AF4F54A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75795502"/>
              </p:ext>
            </p:extLst>
          </p:nvPr>
        </p:nvGraphicFramePr>
        <p:xfrm>
          <a:off x="1212103" y="2708661"/>
          <a:ext cx="6677247" cy="3362530"/>
        </p:xfrm>
        <a:graphic>
          <a:graphicData uri="http://schemas.openxmlformats.org/drawingml/2006/table">
            <a:tbl>
              <a:tblPr/>
              <a:tblGrid>
                <a:gridCol w="1988297">
                  <a:extLst>
                    <a:ext uri="{9D8B030D-6E8A-4147-A177-3AD203B41FA5}">
                      <a16:colId xmlns:a16="http://schemas.microsoft.com/office/drawing/2014/main" val="2617226399"/>
                    </a:ext>
                  </a:extLst>
                </a:gridCol>
                <a:gridCol w="1158949">
                  <a:extLst>
                    <a:ext uri="{9D8B030D-6E8A-4147-A177-3AD203B41FA5}">
                      <a16:colId xmlns:a16="http://schemas.microsoft.com/office/drawing/2014/main" val="4164117664"/>
                    </a:ext>
                  </a:extLst>
                </a:gridCol>
                <a:gridCol w="1158949">
                  <a:extLst>
                    <a:ext uri="{9D8B030D-6E8A-4147-A177-3AD203B41FA5}">
                      <a16:colId xmlns:a16="http://schemas.microsoft.com/office/drawing/2014/main" val="3266451441"/>
                    </a:ext>
                  </a:extLst>
                </a:gridCol>
                <a:gridCol w="2371052">
                  <a:extLst>
                    <a:ext uri="{9D8B030D-6E8A-4147-A177-3AD203B41FA5}">
                      <a16:colId xmlns:a16="http://schemas.microsoft.com/office/drawing/2014/main" val="1733520435"/>
                    </a:ext>
                  </a:extLst>
                </a:gridCol>
              </a:tblGrid>
              <a:tr h="45462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Group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Gender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ge</a:t>
                      </a:r>
                      <a:b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（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verage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）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moking history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43817679"/>
                  </a:ext>
                </a:extLst>
              </a:tr>
              <a:tr h="67697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ontrol </a:t>
                      </a:r>
                      <a:b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=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M: 3</a:t>
                      </a:r>
                      <a:b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F: 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urrent/Past smoker: 1</a:t>
                      </a:r>
                      <a:b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on-smoker: 3</a:t>
                      </a:r>
                      <a:b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o answer: 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09907157"/>
                  </a:ext>
                </a:extLst>
              </a:tr>
              <a:tr h="74364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-PT84</a:t>
                      </a:r>
                      <a:b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（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 billion/day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）</a:t>
                      </a:r>
                      <a:b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</a:b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=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M: 3</a:t>
                      </a:r>
                      <a:b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F: 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5.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urrent/Past smoker: 1</a:t>
                      </a:r>
                      <a:b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on-smoker: 3</a:t>
                      </a:r>
                      <a:b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o answer: 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82168178"/>
                  </a:ext>
                </a:extLst>
              </a:tr>
              <a:tr h="74364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-PT84</a:t>
                      </a:r>
                      <a:b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1.5 billion/day)</a:t>
                      </a:r>
                      <a:b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ＭＳ ゴシック" panose="020B0609070205080204" pitchFamily="49" charset="-128"/>
                          <a:ea typeface="ＭＳ ゴシック" panose="020B0609070205080204" pitchFamily="49" charset="-128"/>
                        </a:rPr>
                      </a:b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=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M: 4</a:t>
                      </a:r>
                      <a:b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F: 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2.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urrent/Past smoker: 1</a:t>
                      </a:r>
                      <a:b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on-smoker: 4</a:t>
                      </a:r>
                      <a:b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o answer: 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0536615"/>
                  </a:ext>
                </a:extLst>
              </a:tr>
              <a:tr h="74364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-PT84</a:t>
                      </a:r>
                      <a:b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4.5 billion/day)</a:t>
                      </a:r>
                      <a:b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ＭＳ ゴシック" panose="020B0609070205080204" pitchFamily="49" charset="-128"/>
                          <a:ea typeface="ＭＳ ゴシック" panose="020B0609070205080204" pitchFamily="49" charset="-128"/>
                        </a:rPr>
                      </a:b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=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M: 4</a:t>
                      </a:r>
                      <a:b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F: 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4.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urrent/Past smoker: 2</a:t>
                      </a:r>
                      <a:b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on-smoker: 1</a:t>
                      </a:r>
                      <a:b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o answer: 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8438832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251175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752</TotalTime>
  <Words>209</Words>
  <Application>Microsoft Macintosh PowerPoint</Application>
  <PresentationFormat>画面に合わせる (4:3)</PresentationFormat>
  <Paragraphs>3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BIZ UDPゴシック</vt:lpstr>
      <vt:lpstr>ＭＳ 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no</dc:creator>
  <cp:lastModifiedBy>酒井 敏行</cp:lastModifiedBy>
  <cp:revision>6</cp:revision>
  <dcterms:created xsi:type="dcterms:W3CDTF">2023-07-31T00:22:39Z</dcterms:created>
  <dcterms:modified xsi:type="dcterms:W3CDTF">2023-08-01T05:18:30Z</dcterms:modified>
</cp:coreProperties>
</file>